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2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1686" y="-15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ffan%20Baig\Desktop\Proteomics%20Paper\Affan_Protein%20Quantity%20Graph%20Table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ffan%20Baig\Desktop\Proteomics%20Paper\Affan_Protein%20Quantity%20Graph%20Table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ffan%20Baig\Desktop\Proteomics%20Paper\Affan_Protein%20Quantity%20Graph%20Table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ffan%20Baig\Desktop\Proteomics%20Paper\Affan_Protein%20Quantity%20Graph%20Table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ffan%20Baig\Desktop\Proteomics%20Paper\Affan_Protein%20Quantity%20Graph%20Table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ffan%20Baig\Desktop\Proteomics%20Paper\Affan_Protein%20Quantity%20Graph%20Tabl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</c:errBars>
          <c:cat>
            <c:strRef>
              <c:f>Sheet1!$C$31:$C$33</c:f>
              <c:strCache>
                <c:ptCount val="3"/>
                <c:pt idx="0">
                  <c:v>Control</c:v>
                </c:pt>
                <c:pt idx="1">
                  <c:v>Lead</c:v>
                </c:pt>
                <c:pt idx="2">
                  <c:v>Mercury</c:v>
                </c:pt>
              </c:strCache>
            </c:strRef>
          </c:cat>
          <c:val>
            <c:numRef>
              <c:f>Sheet1!$D$31:$D$33</c:f>
              <c:numCache>
                <c:formatCode>General</c:formatCode>
                <c:ptCount val="3"/>
                <c:pt idx="0">
                  <c:v>27264.4336</c:v>
                </c:pt>
                <c:pt idx="1">
                  <c:v>62081.765599999999</c:v>
                </c:pt>
                <c:pt idx="2">
                  <c:v>52760.970700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9DC-4035-B83A-88432A42EB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5"/>
        <c:overlap val="-27"/>
        <c:axId val="68673536"/>
        <c:axId val="68675072"/>
      </c:barChart>
      <c:catAx>
        <c:axId val="686735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8675072"/>
        <c:crosses val="autoZero"/>
        <c:auto val="1"/>
        <c:lblAlgn val="ctr"/>
        <c:lblOffset val="100"/>
        <c:noMultiLvlLbl val="0"/>
      </c:catAx>
      <c:valAx>
        <c:axId val="68675072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one"/>
        <c:crossAx val="686735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</c:errBars>
          <c:cat>
            <c:strRef>
              <c:f>Sheet1!$C$121:$C$123</c:f>
              <c:strCache>
                <c:ptCount val="3"/>
                <c:pt idx="0">
                  <c:v>Control</c:v>
                </c:pt>
                <c:pt idx="1">
                  <c:v>Lead</c:v>
                </c:pt>
                <c:pt idx="2">
                  <c:v>Mercury</c:v>
                </c:pt>
              </c:strCache>
            </c:strRef>
          </c:cat>
          <c:val>
            <c:numRef>
              <c:f>Sheet1!$D$121:$D$123</c:f>
              <c:numCache>
                <c:formatCode>General</c:formatCode>
                <c:ptCount val="3"/>
                <c:pt idx="0">
                  <c:v>2573.786599999994</c:v>
                </c:pt>
                <c:pt idx="1">
                  <c:v>10120.375999999953</c:v>
                </c:pt>
                <c:pt idx="2">
                  <c:v>6864.92290000000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9C5-41C6-A4B4-F335747314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5"/>
        <c:overlap val="-27"/>
        <c:axId val="69018752"/>
        <c:axId val="69020288"/>
      </c:barChart>
      <c:catAx>
        <c:axId val="690187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020288"/>
        <c:crosses val="autoZero"/>
        <c:auto val="1"/>
        <c:lblAlgn val="ctr"/>
        <c:lblOffset val="100"/>
        <c:noMultiLvlLbl val="0"/>
      </c:catAx>
      <c:valAx>
        <c:axId val="69020288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one"/>
        <c:crossAx val="690187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</c:errBars>
          <c:cat>
            <c:strRef>
              <c:f>Sheet1!$C$281:$C$283</c:f>
              <c:strCache>
                <c:ptCount val="3"/>
                <c:pt idx="0">
                  <c:v>Control</c:v>
                </c:pt>
                <c:pt idx="1">
                  <c:v>Lead</c:v>
                </c:pt>
                <c:pt idx="2">
                  <c:v>Mercury</c:v>
                </c:pt>
              </c:strCache>
            </c:strRef>
          </c:cat>
          <c:val>
            <c:numRef>
              <c:f>Sheet1!$D$281:$D$283</c:f>
              <c:numCache>
                <c:formatCode>General</c:formatCode>
                <c:ptCount val="3"/>
                <c:pt idx="0">
                  <c:v>4889.0249000000003</c:v>
                </c:pt>
                <c:pt idx="1">
                  <c:v>6651.1250000000109</c:v>
                </c:pt>
                <c:pt idx="2">
                  <c:v>3397.2793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A46-4B6F-9E67-AE36AD54D5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5"/>
        <c:overlap val="-27"/>
        <c:axId val="69044480"/>
        <c:axId val="69472256"/>
      </c:barChart>
      <c:catAx>
        <c:axId val="69044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472256"/>
        <c:crosses val="autoZero"/>
        <c:auto val="1"/>
        <c:lblAlgn val="ctr"/>
        <c:lblOffset val="100"/>
        <c:noMultiLvlLbl val="0"/>
      </c:catAx>
      <c:valAx>
        <c:axId val="69472256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one"/>
        <c:crossAx val="690444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</c:errBars>
          <c:cat>
            <c:strRef>
              <c:f>Sheet1!$C$311:$C$313</c:f>
              <c:strCache>
                <c:ptCount val="3"/>
                <c:pt idx="0">
                  <c:v>Control</c:v>
                </c:pt>
                <c:pt idx="1">
                  <c:v>Lead</c:v>
                </c:pt>
                <c:pt idx="2">
                  <c:v>Mercury</c:v>
                </c:pt>
              </c:strCache>
            </c:strRef>
          </c:cat>
          <c:val>
            <c:numRef>
              <c:f>Sheet1!$D$311:$D$313</c:f>
              <c:numCache>
                <c:formatCode>General</c:formatCode>
                <c:ptCount val="3"/>
                <c:pt idx="0">
                  <c:v>6332.1338000000005</c:v>
                </c:pt>
                <c:pt idx="1">
                  <c:v>8764.796899999983</c:v>
                </c:pt>
                <c:pt idx="2">
                  <c:v>15454.38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6E0-4CC7-BFF6-0C9610043A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5"/>
        <c:overlap val="-27"/>
        <c:axId val="69488000"/>
        <c:axId val="69493888"/>
      </c:barChart>
      <c:catAx>
        <c:axId val="694880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493888"/>
        <c:crosses val="autoZero"/>
        <c:auto val="1"/>
        <c:lblAlgn val="ctr"/>
        <c:lblOffset val="100"/>
        <c:noMultiLvlLbl val="0"/>
      </c:catAx>
      <c:valAx>
        <c:axId val="69493888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one"/>
        <c:crossAx val="694880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</c:errBars>
          <c:cat>
            <c:strRef>
              <c:f>Sheet1!$C$361:$C$363</c:f>
              <c:strCache>
                <c:ptCount val="3"/>
                <c:pt idx="0">
                  <c:v>Control</c:v>
                </c:pt>
                <c:pt idx="1">
                  <c:v>Lead</c:v>
                </c:pt>
                <c:pt idx="2">
                  <c:v>Mercury</c:v>
                </c:pt>
              </c:strCache>
            </c:strRef>
          </c:cat>
          <c:val>
            <c:numRef>
              <c:f>Sheet1!$D$361:$D$363</c:f>
              <c:numCache>
                <c:formatCode>General</c:formatCode>
                <c:ptCount val="3"/>
                <c:pt idx="0">
                  <c:v>9417.7324000000226</c:v>
                </c:pt>
                <c:pt idx="1">
                  <c:v>13225.022499999999</c:v>
                </c:pt>
                <c:pt idx="2">
                  <c:v>2966.9263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588-4EB2-92CF-3498A9ABCE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5"/>
        <c:overlap val="-27"/>
        <c:axId val="69605248"/>
        <c:axId val="69606784"/>
      </c:barChart>
      <c:catAx>
        <c:axId val="696052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606784"/>
        <c:crosses val="autoZero"/>
        <c:auto val="1"/>
        <c:lblAlgn val="ctr"/>
        <c:lblOffset val="100"/>
        <c:noMultiLvlLbl val="0"/>
      </c:catAx>
      <c:valAx>
        <c:axId val="69606784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one"/>
        <c:crossAx val="696052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</c:errBars>
          <c:cat>
            <c:strRef>
              <c:f>Sheet1!$C$461:$C$463</c:f>
              <c:strCache>
                <c:ptCount val="3"/>
                <c:pt idx="0">
                  <c:v>Control</c:v>
                </c:pt>
                <c:pt idx="1">
                  <c:v>Lead</c:v>
                </c:pt>
                <c:pt idx="2">
                  <c:v>Mercury</c:v>
                </c:pt>
              </c:strCache>
            </c:strRef>
          </c:cat>
          <c:val>
            <c:numRef>
              <c:f>Sheet1!$D$461:$D$463</c:f>
              <c:numCache>
                <c:formatCode>General</c:formatCode>
                <c:ptCount val="3"/>
                <c:pt idx="0">
                  <c:v>4183.7925000000014</c:v>
                </c:pt>
                <c:pt idx="1">
                  <c:v>6171.7832000000008</c:v>
                </c:pt>
                <c:pt idx="2">
                  <c:v>4864.92290000000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B63-4D62-B9D2-EE8AD270B8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5"/>
        <c:overlap val="-27"/>
        <c:axId val="69614592"/>
        <c:axId val="69628672"/>
      </c:barChart>
      <c:catAx>
        <c:axId val="696145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628672"/>
        <c:crosses val="autoZero"/>
        <c:auto val="1"/>
        <c:lblAlgn val="ctr"/>
        <c:lblOffset val="100"/>
        <c:noMultiLvlLbl val="0"/>
      </c:catAx>
      <c:valAx>
        <c:axId val="69628672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one"/>
        <c:crossAx val="696145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9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.xml"/><Relationship Id="rId3" Type="http://schemas.openxmlformats.org/officeDocument/2006/relationships/image" Target="../media/image2.jpeg"/><Relationship Id="rId7" Type="http://schemas.openxmlformats.org/officeDocument/2006/relationships/chart" Target="../charts/chart2.xml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.xml"/><Relationship Id="rId11" Type="http://schemas.openxmlformats.org/officeDocument/2006/relationships/chart" Target="../charts/chart6.xml"/><Relationship Id="rId5" Type="http://schemas.openxmlformats.org/officeDocument/2006/relationships/image" Target="../media/image4.jpeg"/><Relationship Id="rId10" Type="http://schemas.openxmlformats.org/officeDocument/2006/relationships/chart" Target="../charts/chart5.xml"/><Relationship Id="rId4" Type="http://schemas.openxmlformats.org/officeDocument/2006/relationships/image" Target="../media/image3.jpeg"/><Relationship Id="rId9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" name="Picture 74" descr="rotated Hg tif.tif">
            <a:extLst>
              <a:ext uri="{FF2B5EF4-FFF2-40B4-BE49-F238E27FC236}">
                <a16:creationId xmlns:a16="http://schemas.microsoft.com/office/drawing/2014/main" id="{FFE1D81A-63C6-456E-9089-5D3BA7BD779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/>
          <a:srcRect l="70945" t="26353" r="24128" b="68626"/>
          <a:stretch/>
        </p:blipFill>
        <p:spPr>
          <a:xfrm rot="10800000">
            <a:off x="5086349" y="7256474"/>
            <a:ext cx="361951" cy="364361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2625021"/>
              </p:ext>
            </p:extLst>
          </p:nvPr>
        </p:nvGraphicFramePr>
        <p:xfrm>
          <a:off x="563243" y="470098"/>
          <a:ext cx="2105472" cy="1152525"/>
        </p:xfrm>
        <a:graphic>
          <a:graphicData uri="http://schemas.openxmlformats.org/drawingml/2006/table">
            <a:tbl>
              <a:tblPr>
                <a:tableStyleId>{1FECB4D8-DB02-4DC6-A0A2-4F2EBAE1DC90}</a:tableStyleId>
              </a:tblPr>
              <a:tblGrid>
                <a:gridCol w="80835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6211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5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81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/>
                        <a:t>Protein</a:t>
                      </a:r>
                      <a:endParaRPr lang="en-US" sz="1400" b="1" i="0" u="none" strike="noStrike" dirty="0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u="none" strike="noStrike" kern="1200" dirty="0" err="1"/>
                        <a:t>Trt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/>
                        <a:t>Qty</a:t>
                      </a:r>
                      <a:endParaRPr lang="en-US" sz="1400" b="1" i="0" u="none" strike="noStrike" dirty="0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1" i="0" u="none" strike="noStrike" dirty="0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CAT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u="none" strike="noStrike" kern="1200" dirty="0"/>
                        <a:t>Con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/>
                        <a:t>27264.4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u="none" strike="noStrike" kern="1200" dirty="0"/>
                        <a:t>Pb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/>
                        <a:t>62081.7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u="none" strike="noStrike" kern="1200" dirty="0"/>
                        <a:t>Hg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/>
                        <a:t>5276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grpSp>
        <p:nvGrpSpPr>
          <p:cNvPr id="2" name="Group 67"/>
          <p:cNvGrpSpPr/>
          <p:nvPr/>
        </p:nvGrpSpPr>
        <p:grpSpPr>
          <a:xfrm>
            <a:off x="4130040" y="958227"/>
            <a:ext cx="1382892" cy="377022"/>
            <a:chOff x="4130040" y="958227"/>
            <a:chExt cx="1382892" cy="377022"/>
          </a:xfrm>
        </p:grpSpPr>
        <p:pic>
          <p:nvPicPr>
            <p:cNvPr id="9" name="Picture 8" descr="pb.jpg">
              <a:extLst>
                <a:ext uri="{FF2B5EF4-FFF2-40B4-BE49-F238E27FC236}">
                  <a16:creationId xmlns:a16="http://schemas.microsoft.com/office/drawing/2014/main" id="{93FC1E6F-B1F9-4279-A3B2-9AC616C114D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/>
            <a:srcRect l="53608" t="23006" r="41262" b="71973"/>
            <a:stretch/>
          </p:blipFill>
          <p:spPr>
            <a:xfrm>
              <a:off x="4648297" y="965724"/>
              <a:ext cx="357619" cy="36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grpSp>
          <p:nvGrpSpPr>
            <p:cNvPr id="3" name="Group 69"/>
            <p:cNvGrpSpPr/>
            <p:nvPr/>
          </p:nvGrpSpPr>
          <p:grpSpPr>
            <a:xfrm>
              <a:off x="4130040" y="958227"/>
              <a:ext cx="1382892" cy="377022"/>
              <a:chOff x="0" y="0"/>
              <a:chExt cx="1382892" cy="377022"/>
            </a:xfrm>
          </p:grpSpPr>
          <p:pic>
            <p:nvPicPr>
              <p:cNvPr id="11" name="Picture 10" descr="Control rotate.jpg">
                <a:extLst>
                  <a:ext uri="{FF2B5EF4-FFF2-40B4-BE49-F238E27FC236}">
                    <a16:creationId xmlns:a16="http://schemas.microsoft.com/office/drawing/2014/main" id="{0BF35116-58F1-4EE1-A12A-53F4B28782B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/>
              <a:srcRect l="49952" t="21130" r="45113" b="73937"/>
              <a:stretch/>
            </p:blipFill>
            <p:spPr>
              <a:xfrm>
                <a:off x="0" y="0"/>
                <a:ext cx="360000" cy="360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40819FC2-A356-4EDE-B151-41A7CA880B6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2735" t="21294" r="53789" b="75556"/>
              <a:stretch/>
            </p:blipFill>
            <p:spPr>
              <a:xfrm>
                <a:off x="1025274" y="17022"/>
                <a:ext cx="357618" cy="360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cxnSp>
            <p:nvCxnSpPr>
              <p:cNvPr id="13" name="Straight Arrow Connector 12">
                <a:extLst>
                  <a:ext uri="{FF2B5EF4-FFF2-40B4-BE49-F238E27FC236}">
                    <a16:creationId xmlns:a16="http://schemas.microsoft.com/office/drawing/2014/main" id="{5D308DF9-7975-469C-8BC2-2F7E7B9655C8}"/>
                  </a:ext>
                </a:extLst>
              </p:cNvPr>
              <p:cNvCxnSpPr/>
              <p:nvPr/>
            </p:nvCxnSpPr>
            <p:spPr>
              <a:xfrm flipH="1" flipV="1">
                <a:off x="190500" y="200025"/>
                <a:ext cx="114300" cy="104775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accent2"/>
              </a:lnRef>
              <a:fillRef idx="0">
                <a:schemeClr val="accent2"/>
              </a:fillRef>
              <a:effectRef idx="1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4" name="Straight Arrow Connector 13">
                <a:extLst>
                  <a:ext uri="{FF2B5EF4-FFF2-40B4-BE49-F238E27FC236}">
                    <a16:creationId xmlns:a16="http://schemas.microsoft.com/office/drawing/2014/main" id="{14607C64-BE04-421F-AA49-D7884712497B}"/>
                  </a:ext>
                </a:extLst>
              </p:cNvPr>
              <p:cNvCxnSpPr/>
              <p:nvPr/>
            </p:nvCxnSpPr>
            <p:spPr>
              <a:xfrm flipH="1" flipV="1">
                <a:off x="1171575" y="228600"/>
                <a:ext cx="114300" cy="104775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accent2"/>
              </a:lnRef>
              <a:fillRef idx="0">
                <a:schemeClr val="accent2"/>
              </a:fillRef>
              <a:effectRef idx="1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5" name="Straight Arrow Connector 14">
                <a:extLst>
                  <a:ext uri="{FF2B5EF4-FFF2-40B4-BE49-F238E27FC236}">
                    <a16:creationId xmlns:a16="http://schemas.microsoft.com/office/drawing/2014/main" id="{CAE4E121-3838-4259-9125-A88BD3F511DE}"/>
                  </a:ext>
                </a:extLst>
              </p:cNvPr>
              <p:cNvCxnSpPr/>
              <p:nvPr/>
            </p:nvCxnSpPr>
            <p:spPr>
              <a:xfrm flipH="1" flipV="1">
                <a:off x="666750" y="209550"/>
                <a:ext cx="114300" cy="104775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accent2"/>
              </a:lnRef>
              <a:fillRef idx="0">
                <a:schemeClr val="accent2"/>
              </a:fillRef>
              <a:effectRef idx="1">
                <a:schemeClr val="accent2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" name="Group 68"/>
          <p:cNvGrpSpPr/>
          <p:nvPr/>
        </p:nvGrpSpPr>
        <p:grpSpPr>
          <a:xfrm>
            <a:off x="4175760" y="2118360"/>
            <a:ext cx="1316883" cy="361512"/>
            <a:chOff x="4175760" y="2118360"/>
            <a:chExt cx="1316883" cy="361512"/>
          </a:xfrm>
        </p:grpSpPr>
        <p:pic>
          <p:nvPicPr>
            <p:cNvPr id="17" name="Picture 16" descr="Control rotate.jpg">
              <a:extLst>
                <a:ext uri="{FF2B5EF4-FFF2-40B4-BE49-F238E27FC236}">
                  <a16:creationId xmlns:a16="http://schemas.microsoft.com/office/drawing/2014/main" id="{B398A6DA-F07F-4099-8FFD-8D747E34B6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/>
            <a:srcRect l="77915" t="27708" r="17151" b="67358"/>
            <a:stretch/>
          </p:blipFill>
          <p:spPr>
            <a:xfrm>
              <a:off x="4175760" y="2118360"/>
              <a:ext cx="360000" cy="36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8" name="Picture 17" descr="pb.jpg">
              <a:extLst>
                <a:ext uri="{FF2B5EF4-FFF2-40B4-BE49-F238E27FC236}">
                  <a16:creationId xmlns:a16="http://schemas.microsoft.com/office/drawing/2014/main" id="{57A3948F-DF05-49DF-90FE-8DCB3575FE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/>
            <a:srcRect l="80370" t="30132" r="14500" b="64846"/>
            <a:stretch/>
          </p:blipFill>
          <p:spPr>
            <a:xfrm>
              <a:off x="4640558" y="2119872"/>
              <a:ext cx="357619" cy="36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9" name="Picture 18" descr="rotated Hg tif.tif">
              <a:extLst>
                <a:ext uri="{FF2B5EF4-FFF2-40B4-BE49-F238E27FC236}">
                  <a16:creationId xmlns:a16="http://schemas.microsoft.com/office/drawing/2014/main" id="{FFE1D81A-63C6-456E-9089-5D3BA7BD77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/>
            <a:srcRect l="70945" t="26353" r="24128" b="68626"/>
            <a:stretch/>
          </p:blipFill>
          <p:spPr>
            <a:xfrm>
              <a:off x="5135025" y="2118489"/>
              <a:ext cx="357618" cy="36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652AC8F3-E40B-4DC9-A190-EF4BE352C285}"/>
                </a:ext>
              </a:extLst>
            </p:cNvPr>
            <p:cNvCxnSpPr/>
            <p:nvPr/>
          </p:nvCxnSpPr>
          <p:spPr>
            <a:xfrm flipV="1">
              <a:off x="4204335" y="2347089"/>
              <a:ext cx="133350" cy="9525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FF2D1224-3F24-4836-B4E8-A3FE86C53038}"/>
                </a:ext>
              </a:extLst>
            </p:cNvPr>
            <p:cNvCxnSpPr/>
            <p:nvPr/>
          </p:nvCxnSpPr>
          <p:spPr>
            <a:xfrm flipV="1">
              <a:off x="5213985" y="2270889"/>
              <a:ext cx="133350" cy="9525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2" name="Straight Arrow Connector 21">
              <a:extLst>
                <a:ext uri="{FF2B5EF4-FFF2-40B4-BE49-F238E27FC236}">
                  <a16:creationId xmlns:a16="http://schemas.microsoft.com/office/drawing/2014/main" id="{C72D7261-DE74-487B-8C15-086D8FFD133C}"/>
                </a:ext>
              </a:extLst>
            </p:cNvPr>
            <p:cNvCxnSpPr/>
            <p:nvPr/>
          </p:nvCxnSpPr>
          <p:spPr>
            <a:xfrm flipV="1">
              <a:off x="4709160" y="2328039"/>
              <a:ext cx="133350" cy="9525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6" name="Group 69"/>
          <p:cNvGrpSpPr/>
          <p:nvPr/>
        </p:nvGrpSpPr>
        <p:grpSpPr>
          <a:xfrm>
            <a:off x="4114800" y="3276600"/>
            <a:ext cx="1297100" cy="372702"/>
            <a:chOff x="4114800" y="3276600"/>
            <a:chExt cx="1297100" cy="372702"/>
          </a:xfrm>
        </p:grpSpPr>
        <p:pic>
          <p:nvPicPr>
            <p:cNvPr id="24" name="Picture 23" descr="Control rotate.jpg">
              <a:extLst>
                <a:ext uri="{FF2B5EF4-FFF2-40B4-BE49-F238E27FC236}">
                  <a16:creationId xmlns:a16="http://schemas.microsoft.com/office/drawing/2014/main" id="{A5F17666-7775-481A-899B-38161A6544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/>
            <a:srcRect l="49954" t="44155" r="45112" b="50910"/>
            <a:stretch/>
          </p:blipFill>
          <p:spPr>
            <a:xfrm>
              <a:off x="4114800" y="3289302"/>
              <a:ext cx="360000" cy="36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5" name="Picture 24" descr="pb.jpg">
              <a:extLst>
                <a:ext uri="{FF2B5EF4-FFF2-40B4-BE49-F238E27FC236}">
                  <a16:creationId xmlns:a16="http://schemas.microsoft.com/office/drawing/2014/main" id="{2D6C8FBC-F6F7-4C66-872E-A3BCA76AB7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/>
            <a:srcRect l="51897" t="46439" r="42973" b="48539"/>
            <a:stretch/>
          </p:blipFill>
          <p:spPr>
            <a:xfrm>
              <a:off x="4583868" y="3276602"/>
              <a:ext cx="357619" cy="36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6" name="Picture 25" descr="rotated Hg tif.tif">
              <a:extLst>
                <a:ext uri="{FF2B5EF4-FFF2-40B4-BE49-F238E27FC236}">
                  <a16:creationId xmlns:a16="http://schemas.microsoft.com/office/drawing/2014/main" id="{4E22E77C-3203-4B6D-BCE5-A14987E59E6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/>
            <a:srcRect l="47951" t="44765" r="47121" b="50214"/>
            <a:stretch/>
          </p:blipFill>
          <p:spPr>
            <a:xfrm>
              <a:off x="5054282" y="3276600"/>
              <a:ext cx="357618" cy="360002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cxnSp>
          <p:nvCxnSpPr>
            <p:cNvPr id="27" name="Straight Arrow Connector 26">
              <a:extLst>
                <a:ext uri="{FF2B5EF4-FFF2-40B4-BE49-F238E27FC236}">
                  <a16:creationId xmlns:a16="http://schemas.microsoft.com/office/drawing/2014/main" id="{15A471F6-8F72-437E-A786-F08CBE48EE63}"/>
                </a:ext>
              </a:extLst>
            </p:cNvPr>
            <p:cNvCxnSpPr/>
            <p:nvPr/>
          </p:nvCxnSpPr>
          <p:spPr>
            <a:xfrm flipV="1">
              <a:off x="4162424" y="3455194"/>
              <a:ext cx="95250" cy="154781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8" name="Straight Arrow Connector 27">
              <a:extLst>
                <a:ext uri="{FF2B5EF4-FFF2-40B4-BE49-F238E27FC236}">
                  <a16:creationId xmlns:a16="http://schemas.microsoft.com/office/drawing/2014/main" id="{6DE54425-5C78-426C-A836-745F14AC0F8C}"/>
                </a:ext>
              </a:extLst>
            </p:cNvPr>
            <p:cNvCxnSpPr/>
            <p:nvPr/>
          </p:nvCxnSpPr>
          <p:spPr>
            <a:xfrm flipV="1">
              <a:off x="4636294" y="3464718"/>
              <a:ext cx="95250" cy="154781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3B8C2500-A4F6-4017-A6A6-62C83AD765E0}"/>
                </a:ext>
              </a:extLst>
            </p:cNvPr>
            <p:cNvCxnSpPr/>
            <p:nvPr/>
          </p:nvCxnSpPr>
          <p:spPr>
            <a:xfrm flipV="1">
              <a:off x="5181600" y="3426618"/>
              <a:ext cx="95250" cy="154781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7" name="Group 70"/>
          <p:cNvGrpSpPr/>
          <p:nvPr/>
        </p:nvGrpSpPr>
        <p:grpSpPr>
          <a:xfrm>
            <a:off x="4130040" y="4678680"/>
            <a:ext cx="1298421" cy="365963"/>
            <a:chOff x="4130040" y="4678680"/>
            <a:chExt cx="1298421" cy="365963"/>
          </a:xfrm>
        </p:grpSpPr>
        <p:pic>
          <p:nvPicPr>
            <p:cNvPr id="31" name="Picture 30" descr="Control rotate.jpg">
              <a:extLst>
                <a:ext uri="{FF2B5EF4-FFF2-40B4-BE49-F238E27FC236}">
                  <a16:creationId xmlns:a16="http://schemas.microsoft.com/office/drawing/2014/main" id="{57EC01ED-4896-4C1F-8038-6E41C3734C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/>
            <a:srcRect l="37835" t="49340" r="57230" b="45726"/>
            <a:stretch/>
          </p:blipFill>
          <p:spPr>
            <a:xfrm>
              <a:off x="4130040" y="4684643"/>
              <a:ext cx="360000" cy="36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2" name="Picture 31" descr="pb.jpg">
              <a:extLst>
                <a:ext uri="{FF2B5EF4-FFF2-40B4-BE49-F238E27FC236}">
                  <a16:creationId xmlns:a16="http://schemas.microsoft.com/office/drawing/2014/main" id="{A7ECF617-BD5B-4D37-8E75-B06A93AA3D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/>
            <a:srcRect l="38219" t="51460" r="56652" b="43519"/>
            <a:stretch/>
          </p:blipFill>
          <p:spPr>
            <a:xfrm>
              <a:off x="4611809" y="4678680"/>
              <a:ext cx="357619" cy="36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3" name="Picture 32" descr="rotated Hg tif.tif">
              <a:extLst>
                <a:ext uri="{FF2B5EF4-FFF2-40B4-BE49-F238E27FC236}">
                  <a16:creationId xmlns:a16="http://schemas.microsoft.com/office/drawing/2014/main" id="{7AD1B870-B8D1-4C47-B079-51796F64880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/>
            <a:srcRect l="38095" t="48112" r="56977" b="46867"/>
            <a:stretch/>
          </p:blipFill>
          <p:spPr>
            <a:xfrm>
              <a:off x="5070843" y="4678681"/>
              <a:ext cx="357618" cy="359998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cxnSp>
          <p:nvCxnSpPr>
            <p:cNvPr id="34" name="Straight Arrow Connector 33">
              <a:extLst>
                <a:ext uri="{FF2B5EF4-FFF2-40B4-BE49-F238E27FC236}">
                  <a16:creationId xmlns:a16="http://schemas.microsoft.com/office/drawing/2014/main" id="{168CCBFE-1BE3-4BE6-B717-1720E5174657}"/>
                </a:ext>
              </a:extLst>
            </p:cNvPr>
            <p:cNvCxnSpPr/>
            <p:nvPr/>
          </p:nvCxnSpPr>
          <p:spPr>
            <a:xfrm flipV="1">
              <a:off x="4191952" y="4895374"/>
              <a:ext cx="83344" cy="130968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5" name="Straight Arrow Connector 34">
              <a:extLst>
                <a:ext uri="{FF2B5EF4-FFF2-40B4-BE49-F238E27FC236}">
                  <a16:creationId xmlns:a16="http://schemas.microsoft.com/office/drawing/2014/main" id="{49E0C5ED-1EB1-4577-883C-B4B4B30A7DBC}"/>
                </a:ext>
              </a:extLst>
            </p:cNvPr>
            <p:cNvCxnSpPr/>
            <p:nvPr/>
          </p:nvCxnSpPr>
          <p:spPr>
            <a:xfrm flipV="1">
              <a:off x="4658677" y="4897755"/>
              <a:ext cx="83344" cy="130968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6" name="Straight Arrow Connector 35">
              <a:extLst>
                <a:ext uri="{FF2B5EF4-FFF2-40B4-BE49-F238E27FC236}">
                  <a16:creationId xmlns:a16="http://schemas.microsoft.com/office/drawing/2014/main" id="{C847DC85-B6DB-4D6E-80C4-75AB1CC5E122}"/>
                </a:ext>
              </a:extLst>
            </p:cNvPr>
            <p:cNvCxnSpPr/>
            <p:nvPr/>
          </p:nvCxnSpPr>
          <p:spPr>
            <a:xfrm flipV="1">
              <a:off x="5127783" y="4907281"/>
              <a:ext cx="83344" cy="130968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</p:grpSp>
      <p:graphicFrame>
        <p:nvGraphicFramePr>
          <p:cNvPr id="37" name="Chart 36">
            <a:extLst>
              <a:ext uri="{FF2B5EF4-FFF2-40B4-BE49-F238E27FC236}">
                <a16:creationId xmlns:a16="http://schemas.microsoft.com/office/drawing/2014/main" id="{00000000-0008-0000-0000-000006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40322623"/>
              </p:ext>
            </p:extLst>
          </p:nvPr>
        </p:nvGraphicFramePr>
        <p:xfrm>
          <a:off x="2682240" y="259080"/>
          <a:ext cx="1442876" cy="14250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8" name="Chart 37">
            <a:extLst>
              <a:ext uri="{FF2B5EF4-FFF2-40B4-BE49-F238E27FC236}">
                <a16:creationId xmlns:a16="http://schemas.microsoft.com/office/drawing/2014/main" id="{00000000-0008-0000-0000-00000F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62665469"/>
              </p:ext>
            </p:extLst>
          </p:nvPr>
        </p:nvGraphicFramePr>
        <p:xfrm>
          <a:off x="2651760" y="1539240"/>
          <a:ext cx="1442876" cy="14250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39" name="Chart 38">
            <a:extLst>
              <a:ext uri="{FF2B5EF4-FFF2-40B4-BE49-F238E27FC236}">
                <a16:creationId xmlns:a16="http://schemas.microsoft.com/office/drawing/2014/main" id="{00000000-0008-0000-0000-00001F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01233434"/>
              </p:ext>
            </p:extLst>
          </p:nvPr>
        </p:nvGraphicFramePr>
        <p:xfrm>
          <a:off x="2667000" y="2819400"/>
          <a:ext cx="1442876" cy="14329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40" name="Chart 39">
            <a:extLst>
              <a:ext uri="{FF2B5EF4-FFF2-40B4-BE49-F238E27FC236}">
                <a16:creationId xmlns:a16="http://schemas.microsoft.com/office/drawing/2014/main" id="{00000000-0008-0000-0000-00002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642833"/>
              </p:ext>
            </p:extLst>
          </p:nvPr>
        </p:nvGraphicFramePr>
        <p:xfrm>
          <a:off x="2682240" y="4145280"/>
          <a:ext cx="1442876" cy="14353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41" name="Rectangle 40"/>
          <p:cNvSpPr/>
          <p:nvPr/>
        </p:nvSpPr>
        <p:spPr>
          <a:xfrm>
            <a:off x="457200" y="8305800"/>
            <a:ext cx="59436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sz="1200" b="1">
                <a:latin typeface="Times New Roman" pitchFamily="18" charset="0"/>
                <a:cs typeface="Times New Roman" pitchFamily="18" charset="0"/>
              </a:rPr>
              <a:t>Figure S1: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Impact of </a:t>
            </a:r>
            <a:r>
              <a:rPr lang="en-IN" sz="1200" dirty="0">
                <a:latin typeface="Times New Roman" pitchFamily="18" charset="0"/>
                <a:cs typeface="Times New Roman" pitchFamily="18" charset="0"/>
              </a:rPr>
              <a:t>Pb and Hg stress on some key proteins of </a:t>
            </a:r>
            <a:r>
              <a:rPr lang="en-IN" sz="1200" i="1" dirty="0" err="1">
                <a:latin typeface="Times New Roman" pitchFamily="18" charset="0"/>
                <a:cs typeface="Times New Roman" pitchFamily="18" charset="0"/>
              </a:rPr>
              <a:t>Glycine</a:t>
            </a:r>
            <a:r>
              <a:rPr lang="en-IN" sz="1200" i="1" dirty="0">
                <a:latin typeface="Times New Roman" pitchFamily="18" charset="0"/>
                <a:cs typeface="Times New Roman" pitchFamily="18" charset="0"/>
              </a:rPr>
              <a:t> max </a:t>
            </a:r>
            <a:r>
              <a:rPr lang="en-IN" sz="1200" dirty="0">
                <a:latin typeface="Times New Roman" pitchFamily="18" charset="0"/>
                <a:cs typeface="Times New Roman" pitchFamily="18" charset="0"/>
              </a:rPr>
              <a:t>L. Changes in actual relative abundance, bar graphs and picture have been demonstrated.</a:t>
            </a:r>
          </a:p>
        </p:txBody>
      </p:sp>
      <p:grpSp>
        <p:nvGrpSpPr>
          <p:cNvPr id="8" name="Group 71"/>
          <p:cNvGrpSpPr/>
          <p:nvPr/>
        </p:nvGrpSpPr>
        <p:grpSpPr>
          <a:xfrm>
            <a:off x="4069080" y="5913120"/>
            <a:ext cx="1369245" cy="379238"/>
            <a:chOff x="4069080" y="5913120"/>
            <a:chExt cx="1369245" cy="379238"/>
          </a:xfrm>
        </p:grpSpPr>
        <p:pic>
          <p:nvPicPr>
            <p:cNvPr id="45" name="Picture 44" descr="Control rotate.jpg">
              <a:extLst>
                <a:ext uri="{FF2B5EF4-FFF2-40B4-BE49-F238E27FC236}">
                  <a16:creationId xmlns:a16="http://schemas.microsoft.com/office/drawing/2014/main" id="{D9485BF1-BD01-41E3-AC85-63A1FA138E6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/>
            <a:srcRect l="67445" t="50995" r="27620" b="44070"/>
            <a:stretch/>
          </p:blipFill>
          <p:spPr>
            <a:xfrm>
              <a:off x="4069080" y="5913120"/>
              <a:ext cx="360000" cy="36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46" name="Picture 45" descr="pb.jpg">
              <a:extLst>
                <a:ext uri="{FF2B5EF4-FFF2-40B4-BE49-F238E27FC236}">
                  <a16:creationId xmlns:a16="http://schemas.microsoft.com/office/drawing/2014/main" id="{4C6B2026-C025-4BC4-83DA-EE85D293109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/>
            <a:srcRect l="70110" t="53557" r="24760" b="41422"/>
            <a:stretch/>
          </p:blipFill>
          <p:spPr>
            <a:xfrm>
              <a:off x="4565928" y="5922277"/>
              <a:ext cx="357619" cy="36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47" name="Picture 46" descr="rotated Hg tif.tif">
              <a:extLst>
                <a:ext uri="{FF2B5EF4-FFF2-40B4-BE49-F238E27FC236}">
                  <a16:creationId xmlns:a16="http://schemas.microsoft.com/office/drawing/2014/main" id="{656E3E4C-60AD-4C7D-94C8-89CA022CBE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/>
            <a:srcRect l="64064" t="50210" r="31008" b="44769"/>
            <a:stretch/>
          </p:blipFill>
          <p:spPr>
            <a:xfrm>
              <a:off x="5080707" y="5932358"/>
              <a:ext cx="357618" cy="36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cxnSp>
          <p:nvCxnSpPr>
            <p:cNvPr id="48" name="Straight Arrow Connector 47">
              <a:extLst>
                <a:ext uri="{FF2B5EF4-FFF2-40B4-BE49-F238E27FC236}">
                  <a16:creationId xmlns:a16="http://schemas.microsoft.com/office/drawing/2014/main" id="{3EBEE59B-63C9-4DB3-A9F6-F24D5E4DC52F}"/>
                </a:ext>
              </a:extLst>
            </p:cNvPr>
            <p:cNvCxnSpPr/>
            <p:nvPr/>
          </p:nvCxnSpPr>
          <p:spPr>
            <a:xfrm flipH="1">
              <a:off x="4269105" y="5951220"/>
              <a:ext cx="123825" cy="85725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9" name="Straight Arrow Connector 48">
              <a:extLst>
                <a:ext uri="{FF2B5EF4-FFF2-40B4-BE49-F238E27FC236}">
                  <a16:creationId xmlns:a16="http://schemas.microsoft.com/office/drawing/2014/main" id="{6A9E9D15-56F5-4EBD-819C-2C9FE8F7B9BA}"/>
                </a:ext>
              </a:extLst>
            </p:cNvPr>
            <p:cNvCxnSpPr/>
            <p:nvPr/>
          </p:nvCxnSpPr>
          <p:spPr>
            <a:xfrm flipH="1">
              <a:off x="4754880" y="5979795"/>
              <a:ext cx="123825" cy="85725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0" name="Straight Arrow Connector 49">
              <a:extLst>
                <a:ext uri="{FF2B5EF4-FFF2-40B4-BE49-F238E27FC236}">
                  <a16:creationId xmlns:a16="http://schemas.microsoft.com/office/drawing/2014/main" id="{072584E6-8513-413C-90C6-E7EEE633ECF1}"/>
                </a:ext>
              </a:extLst>
            </p:cNvPr>
            <p:cNvCxnSpPr/>
            <p:nvPr/>
          </p:nvCxnSpPr>
          <p:spPr>
            <a:xfrm flipH="1">
              <a:off x="5240655" y="6017895"/>
              <a:ext cx="123825" cy="85725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</p:grpSp>
      <p:pic>
        <p:nvPicPr>
          <p:cNvPr id="52" name="Picture 51" descr="Control rotate.jpg">
            <a:extLst>
              <a:ext uri="{FF2B5EF4-FFF2-40B4-BE49-F238E27FC236}">
                <a16:creationId xmlns:a16="http://schemas.microsoft.com/office/drawing/2014/main" id="{E485C339-C53C-4D59-B51A-1210089830A8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/>
          <a:srcRect l="72980" t="85276" r="22085" b="9790"/>
          <a:stretch/>
        </p:blipFill>
        <p:spPr>
          <a:xfrm>
            <a:off x="4084320" y="7254240"/>
            <a:ext cx="36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53" name="Picture 52" descr="pb.jpg">
            <a:extLst>
              <a:ext uri="{FF2B5EF4-FFF2-40B4-BE49-F238E27FC236}">
                <a16:creationId xmlns:a16="http://schemas.microsoft.com/office/drawing/2014/main" id="{B691D91F-6700-4CFC-89CE-C443716948B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/>
          <a:srcRect l="74125" t="86610" r="20745" b="8369"/>
          <a:stretch/>
        </p:blipFill>
        <p:spPr>
          <a:xfrm>
            <a:off x="4612862" y="7254240"/>
            <a:ext cx="357619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F6D5E079-C163-43C9-9030-EA3F6B1E416C}"/>
              </a:ext>
            </a:extLst>
          </p:cNvPr>
          <p:cNvCxnSpPr/>
          <p:nvPr/>
        </p:nvCxnSpPr>
        <p:spPr>
          <a:xfrm flipH="1">
            <a:off x="4274820" y="7282815"/>
            <a:ext cx="142875" cy="104775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B442F6AA-D098-4A8D-A1FD-30AD69DF70E3}"/>
              </a:ext>
            </a:extLst>
          </p:cNvPr>
          <p:cNvCxnSpPr/>
          <p:nvPr/>
        </p:nvCxnSpPr>
        <p:spPr>
          <a:xfrm flipH="1">
            <a:off x="4817745" y="7349490"/>
            <a:ext cx="142875" cy="104775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C635F2DC-1538-431E-9F71-B965B53EA586}"/>
              </a:ext>
            </a:extLst>
          </p:cNvPr>
          <p:cNvCxnSpPr/>
          <p:nvPr/>
        </p:nvCxnSpPr>
        <p:spPr>
          <a:xfrm flipH="1">
            <a:off x="5257800" y="7315200"/>
            <a:ext cx="152400" cy="9525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graphicFrame>
        <p:nvGraphicFramePr>
          <p:cNvPr id="58" name="Chart 57">
            <a:extLst>
              <a:ext uri="{FF2B5EF4-FFF2-40B4-BE49-F238E27FC236}">
                <a16:creationId xmlns:a16="http://schemas.microsoft.com/office/drawing/2014/main" id="{00000000-0008-0000-0000-000027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70128440"/>
              </p:ext>
            </p:extLst>
          </p:nvPr>
        </p:nvGraphicFramePr>
        <p:xfrm>
          <a:off x="2697480" y="5455920"/>
          <a:ext cx="1442876" cy="14250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59" name="Chart 58">
            <a:extLst>
              <a:ext uri="{FF2B5EF4-FFF2-40B4-BE49-F238E27FC236}">
                <a16:creationId xmlns:a16="http://schemas.microsoft.com/office/drawing/2014/main" id="{00000000-0008-0000-0000-000031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23715506"/>
              </p:ext>
            </p:extLst>
          </p:nvPr>
        </p:nvGraphicFramePr>
        <p:xfrm>
          <a:off x="2712720" y="6720840"/>
          <a:ext cx="1442876" cy="14268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60" name="TextBox 59"/>
          <p:cNvSpPr txBox="1"/>
          <p:nvPr/>
        </p:nvSpPr>
        <p:spPr>
          <a:xfrm rot="16200000">
            <a:off x="3921361" y="489384"/>
            <a:ext cx="7251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ontrol</a:t>
            </a:r>
            <a:endParaRPr lang="en-IN" sz="1400" dirty="0"/>
          </a:p>
        </p:txBody>
      </p:sp>
      <p:sp>
        <p:nvSpPr>
          <p:cNvPr id="61" name="TextBox 60"/>
          <p:cNvSpPr txBox="1"/>
          <p:nvPr/>
        </p:nvSpPr>
        <p:spPr>
          <a:xfrm rot="16200000">
            <a:off x="4612703" y="681082"/>
            <a:ext cx="3722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b</a:t>
            </a:r>
            <a:endParaRPr lang="en-IN" sz="1400" dirty="0"/>
          </a:p>
        </p:txBody>
      </p:sp>
      <p:sp>
        <p:nvSpPr>
          <p:cNvPr id="62" name="TextBox 61"/>
          <p:cNvSpPr txBox="1"/>
          <p:nvPr/>
        </p:nvSpPr>
        <p:spPr>
          <a:xfrm rot="16200000">
            <a:off x="5141294" y="676273"/>
            <a:ext cx="3818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Hg</a:t>
            </a:r>
            <a:endParaRPr lang="en-IN" sz="1400" dirty="0"/>
          </a:p>
        </p:txBody>
      </p:sp>
      <p:graphicFrame>
        <p:nvGraphicFramePr>
          <p:cNvPr id="63" name="Table 6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2625021"/>
              </p:ext>
            </p:extLst>
          </p:nvPr>
        </p:nvGraphicFramePr>
        <p:xfrm>
          <a:off x="548640" y="1752600"/>
          <a:ext cx="2105472" cy="1152525"/>
        </p:xfrm>
        <a:graphic>
          <a:graphicData uri="http://schemas.openxmlformats.org/drawingml/2006/table">
            <a:tbl>
              <a:tblPr>
                <a:tableStyleId>{1FECB4D8-DB02-4DC6-A0A2-4F2EBAE1DC90}</a:tableStyleId>
              </a:tblPr>
              <a:tblGrid>
                <a:gridCol w="80835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6211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5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81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/>
                        <a:t>Protein</a:t>
                      </a:r>
                      <a:endParaRPr lang="en-US" sz="1400" b="1" i="0" u="none" strike="noStrike" dirty="0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u="none" strike="noStrike" kern="1200" dirty="0" err="1"/>
                        <a:t>Trt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/>
                        <a:t>Qty</a:t>
                      </a:r>
                      <a:endParaRPr lang="en-US" sz="1400" b="1" i="0" u="none" strike="noStrike" dirty="0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1" i="0" u="none" strike="noStrike" dirty="0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/>
                        <a:t>AO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u="none" strike="noStrike" kern="1200" dirty="0"/>
                        <a:t>Con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573.787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u="none" strike="noStrike" kern="1200" dirty="0"/>
                        <a:t>Pb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0120.38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u="none" strike="noStrike" kern="1200" dirty="0"/>
                        <a:t>Hg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864.92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graphicFrame>
        <p:nvGraphicFramePr>
          <p:cNvPr id="64" name="Table 6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2625021"/>
              </p:ext>
            </p:extLst>
          </p:nvPr>
        </p:nvGraphicFramePr>
        <p:xfrm>
          <a:off x="548640" y="3048000"/>
          <a:ext cx="2105472" cy="1152525"/>
        </p:xfrm>
        <a:graphic>
          <a:graphicData uri="http://schemas.openxmlformats.org/drawingml/2006/table">
            <a:tbl>
              <a:tblPr>
                <a:tableStyleId>{1FECB4D8-DB02-4DC6-A0A2-4F2EBAE1DC90}</a:tableStyleId>
              </a:tblPr>
              <a:tblGrid>
                <a:gridCol w="80835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6211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5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81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/>
                        <a:t>Protein</a:t>
                      </a:r>
                      <a:endParaRPr lang="en-US" sz="1400" b="1" i="0" u="none" strike="noStrike" dirty="0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u="none" strike="noStrike" kern="1200" dirty="0" err="1"/>
                        <a:t>Trt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/>
                        <a:t>Qty</a:t>
                      </a:r>
                      <a:endParaRPr lang="en-US" sz="1400" b="1" i="0" u="none" strike="noStrike" dirty="0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1" i="0" u="none" strike="noStrike" dirty="0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GST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u="none" strike="noStrike" kern="1200" dirty="0"/>
                        <a:t>Con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marR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4889.025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u="none" strike="noStrike" kern="1200" dirty="0"/>
                        <a:t>Pb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651.125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u="none" strike="noStrike" kern="1200" dirty="0"/>
                        <a:t>Hg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397.279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graphicFrame>
        <p:nvGraphicFramePr>
          <p:cNvPr id="65" name="Table 6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2625021"/>
              </p:ext>
            </p:extLst>
          </p:nvPr>
        </p:nvGraphicFramePr>
        <p:xfrm>
          <a:off x="563880" y="4358640"/>
          <a:ext cx="2105472" cy="1152525"/>
        </p:xfrm>
        <a:graphic>
          <a:graphicData uri="http://schemas.openxmlformats.org/drawingml/2006/table">
            <a:tbl>
              <a:tblPr>
                <a:tableStyleId>{1FECB4D8-DB02-4DC6-A0A2-4F2EBAE1DC90}</a:tableStyleId>
              </a:tblPr>
              <a:tblGrid>
                <a:gridCol w="80835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6211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5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81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/>
                        <a:t>Protein</a:t>
                      </a:r>
                      <a:endParaRPr lang="en-US" sz="1400" b="1" i="0" u="none" strike="noStrike" dirty="0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u="none" strike="noStrike" kern="1200" dirty="0" err="1"/>
                        <a:t>Trt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/>
                        <a:t>Qty</a:t>
                      </a:r>
                      <a:endParaRPr lang="en-US" sz="1400" b="1" i="0" u="none" strike="noStrike" dirty="0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1" i="0" u="none" strike="noStrike" dirty="0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CBL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u="none" strike="noStrike" kern="1200" dirty="0"/>
                        <a:t>Con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332.134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u="none" strike="noStrike" kern="1200" dirty="0"/>
                        <a:t>Pb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8764.797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u="none" strike="noStrike" kern="1200" dirty="0"/>
                        <a:t>Hg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5454.38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graphicFrame>
        <p:nvGraphicFramePr>
          <p:cNvPr id="66" name="Table 6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2625021"/>
              </p:ext>
            </p:extLst>
          </p:nvPr>
        </p:nvGraphicFramePr>
        <p:xfrm>
          <a:off x="563880" y="5669280"/>
          <a:ext cx="2105472" cy="1152525"/>
        </p:xfrm>
        <a:graphic>
          <a:graphicData uri="http://schemas.openxmlformats.org/drawingml/2006/table">
            <a:tbl>
              <a:tblPr>
                <a:tableStyleId>{1FECB4D8-DB02-4DC6-A0A2-4F2EBAE1DC90}</a:tableStyleId>
              </a:tblPr>
              <a:tblGrid>
                <a:gridCol w="80835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6211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5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81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/>
                        <a:t>Protein</a:t>
                      </a:r>
                      <a:endParaRPr lang="en-US" sz="1400" b="1" i="0" u="none" strike="noStrike" dirty="0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u="none" strike="noStrike" kern="1200" dirty="0" err="1"/>
                        <a:t>Trt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/>
                        <a:t>Qty</a:t>
                      </a:r>
                      <a:endParaRPr lang="en-US" sz="1400" b="1" i="0" u="none" strike="noStrike" dirty="0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1" i="0" u="none" strike="noStrike" dirty="0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CML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u="none" strike="noStrike" kern="1200" dirty="0"/>
                        <a:t>Con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/>
                        <a:t>9417.7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u="none" strike="noStrike" kern="1200" dirty="0"/>
                        <a:t>Pb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/>
                        <a:t>13225.0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u="none" strike="noStrike" kern="1200" dirty="0"/>
                        <a:t>Hg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/>
                        <a:t>2966.92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graphicFrame>
        <p:nvGraphicFramePr>
          <p:cNvPr id="67" name="Table 6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2625021"/>
              </p:ext>
            </p:extLst>
          </p:nvPr>
        </p:nvGraphicFramePr>
        <p:xfrm>
          <a:off x="563880" y="6934200"/>
          <a:ext cx="2105472" cy="1152525"/>
        </p:xfrm>
        <a:graphic>
          <a:graphicData uri="http://schemas.openxmlformats.org/drawingml/2006/table">
            <a:tbl>
              <a:tblPr>
                <a:tableStyleId>{1FECB4D8-DB02-4DC6-A0A2-4F2EBAE1DC90}</a:tableStyleId>
              </a:tblPr>
              <a:tblGrid>
                <a:gridCol w="80835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6211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5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81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/>
                        <a:t>Protein</a:t>
                      </a:r>
                      <a:endParaRPr lang="en-US" sz="1400" b="1" i="0" u="none" strike="noStrike" dirty="0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u="none" strike="noStrike" kern="1200" dirty="0" err="1"/>
                        <a:t>Trt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/>
                        <a:t>Qty</a:t>
                      </a:r>
                      <a:endParaRPr lang="en-US" sz="1400" b="1" i="0" u="none" strike="noStrike" dirty="0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400" b="1" i="0" u="none" strike="noStrike" dirty="0">
                        <a:solidFill>
                          <a:srgbClr val="FFFFFF"/>
                        </a:solidFill>
                        <a:latin typeface="Calibri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RAF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u="none" strike="noStrike" kern="1200" dirty="0"/>
                        <a:t>Con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/>
                        <a:t>4183.79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u="none" strike="noStrike" kern="1200" dirty="0"/>
                        <a:t>Pb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/>
                        <a:t>6171.78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u="none" strike="noStrike" kern="1200" dirty="0"/>
                        <a:t>Hg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/>
                        <a:t>4864.9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08</TotalTime>
  <Words>96</Words>
  <Application>Microsoft Office PowerPoint</Application>
  <PresentationFormat>On-screen Show (4:3)</PresentationFormat>
  <Paragraphs>6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BL</dc:creator>
  <cp:lastModifiedBy>g6</cp:lastModifiedBy>
  <cp:revision>36</cp:revision>
  <dcterms:created xsi:type="dcterms:W3CDTF">2006-08-16T00:00:00Z</dcterms:created>
  <dcterms:modified xsi:type="dcterms:W3CDTF">2018-09-21T13:42:22Z</dcterms:modified>
</cp:coreProperties>
</file>